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huravasal Krishnan, Janani (jananimk)" userId="6969b20d-d298-4095-ade9-5a3c5ff7904a" providerId="ADAL" clId="{62745B59-A6AF-46EE-BFF0-65B55D60C69C}"/>
    <pc:docChg chg="modSld">
      <pc:chgData name="Madhuravasal Krishnan, Janani (jananimk)" userId="6969b20d-d298-4095-ade9-5a3c5ff7904a" providerId="ADAL" clId="{62745B59-A6AF-46EE-BFF0-65B55D60C69C}" dt="2024-07-11T18:37:58.366" v="40" actId="123"/>
      <pc:docMkLst>
        <pc:docMk/>
      </pc:docMkLst>
      <pc:sldChg chg="modSp">
        <pc:chgData name="Madhuravasal Krishnan, Janani (jananimk)" userId="6969b20d-d298-4095-ade9-5a3c5ff7904a" providerId="ADAL" clId="{62745B59-A6AF-46EE-BFF0-65B55D60C69C}" dt="2024-07-11T18:37:58.366" v="40" actId="123"/>
        <pc:sldMkLst>
          <pc:docMk/>
          <pc:sldMk cId="433186999" sldId="258"/>
        </pc:sldMkLst>
        <pc:spChg chg="mod">
          <ac:chgData name="Madhuravasal Krishnan, Janani (jananimk)" userId="6969b20d-d298-4095-ade9-5a3c5ff7904a" providerId="ADAL" clId="{62745B59-A6AF-46EE-BFF0-65B55D60C69C}" dt="2024-07-11T18:37:58.366" v="40" actId="123"/>
          <ac:spMkLst>
            <pc:docMk/>
            <pc:sldMk cId="433186999" sldId="258"/>
            <ac:spMk id="7" creationId="{8B1F4489-0969-40FA-8B35-772FAAEC6FEE}"/>
          </ac:spMkLst>
        </pc:spChg>
        <pc:graphicFrameChg chg="mod">
          <ac:chgData name="Madhuravasal Krishnan, Janani (jananimk)" userId="6969b20d-d298-4095-ade9-5a3c5ff7904a" providerId="ADAL" clId="{62745B59-A6AF-46EE-BFF0-65B55D60C69C}" dt="2024-07-11T18:36:16.495" v="36" actId="1036"/>
          <ac:graphicFrameMkLst>
            <pc:docMk/>
            <pc:sldMk cId="433186999" sldId="258"/>
            <ac:graphicFrameMk id="4" creationId="{547EB84A-6586-4CEA-AA4E-0C27E3B711BB}"/>
          </ac:graphicFrameMkLst>
        </pc:graphicFrameChg>
        <pc:graphicFrameChg chg="mod">
          <ac:chgData name="Madhuravasal Krishnan, Janani (jananimk)" userId="6969b20d-d298-4095-ade9-5a3c5ff7904a" providerId="ADAL" clId="{62745B59-A6AF-46EE-BFF0-65B55D60C69C}" dt="2024-07-11T18:36:16.495" v="36" actId="1036"/>
          <ac:graphicFrameMkLst>
            <pc:docMk/>
            <pc:sldMk cId="433186999" sldId="258"/>
            <ac:graphicFrameMk id="6" creationId="{92FEFFB8-244A-413B-B882-96EDBCE23BB2}"/>
          </ac:graphicFrameMkLst>
        </pc:graphicFrameChg>
      </pc:sldChg>
    </pc:docChg>
  </pc:docChgLst>
  <pc:docChgLst>
    <pc:chgData name="Madhuravasal Krishnan, Janani (jananimk)" userId="6969b20d-d298-4095-ade9-5a3c5ff7904a" providerId="ADAL" clId="{5EF75E83-D30B-425D-AABF-C4CD043417C5}"/>
    <pc:docChg chg="addSld modSld">
      <pc:chgData name="Madhuravasal Krishnan, Janani (jananimk)" userId="6969b20d-d298-4095-ade9-5a3c5ff7904a" providerId="ADAL" clId="{5EF75E83-D30B-425D-AABF-C4CD043417C5}" dt="2024-06-12T20:11:16.510" v="20" actId="20577"/>
      <pc:docMkLst>
        <pc:docMk/>
      </pc:docMkLst>
      <pc:sldChg chg="modSp add">
        <pc:chgData name="Madhuravasal Krishnan, Janani (jananimk)" userId="6969b20d-d298-4095-ade9-5a3c5ff7904a" providerId="ADAL" clId="{5EF75E83-D30B-425D-AABF-C4CD043417C5}" dt="2024-06-12T20:11:16.510" v="20" actId="20577"/>
        <pc:sldMkLst>
          <pc:docMk/>
          <pc:sldMk cId="433186999" sldId="258"/>
        </pc:sldMkLst>
        <pc:spChg chg="mod">
          <ac:chgData name="Madhuravasal Krishnan, Janani (jananimk)" userId="6969b20d-d298-4095-ade9-5a3c5ff7904a" providerId="ADAL" clId="{5EF75E83-D30B-425D-AABF-C4CD043417C5}" dt="2024-06-12T20:11:16.510" v="20" actId="20577"/>
          <ac:spMkLst>
            <pc:docMk/>
            <pc:sldMk cId="433186999" sldId="258"/>
            <ac:spMk id="7" creationId="{8B1F4489-0969-40FA-8B35-772FAAEC6FEE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2023/T%20cell%20isolation/March%20control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ailuc-my.sharepoint.com/personal/jananimk_ucmail_uc_edu/Documents/202/ELISA%20for%20Tcell%20infections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521867612063069"/>
          <c:y val="7.3878196074239774E-2"/>
          <c:w val="0.71529991677869531"/>
          <c:h val="0.491591299501454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ontrol 66'!$I$39:$L$3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0399259784898203E-3</c:v>
                  </c:pt>
                  <c:pt idx="2">
                    <c:v>2.0769808777766154E-2</c:v>
                  </c:pt>
                  <c:pt idx="3">
                    <c:v>0.40199629892450867</c:v>
                  </c:pt>
                </c:numCache>
              </c:numRef>
            </c:plus>
            <c:minus>
              <c:numRef>
                <c:f>'Control 66'!$I$39:$L$3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0399259784898203E-3</c:v>
                  </c:pt>
                  <c:pt idx="2">
                    <c:v>2.0769808777766154E-2</c:v>
                  </c:pt>
                  <c:pt idx="3">
                    <c:v>0.401996298924508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ntrol 66'!$I$37:$L$37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Control 66'!$I$38:$L$38</c:f>
              <c:numCache>
                <c:formatCode>General</c:formatCode>
                <c:ptCount val="4"/>
                <c:pt idx="0">
                  <c:v>0</c:v>
                </c:pt>
                <c:pt idx="1">
                  <c:v>2.7460609142281931</c:v>
                </c:pt>
                <c:pt idx="2">
                  <c:v>4.2837188067570988</c:v>
                </c:pt>
                <c:pt idx="3">
                  <c:v>1.46565317132746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CE-40F2-A222-CA1D6B521E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8654064"/>
        <c:axId val="1548653232"/>
      </c:barChart>
      <c:catAx>
        <c:axId val="154865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3232"/>
        <c:crosses val="autoZero"/>
        <c:auto val="1"/>
        <c:lblAlgn val="ctr"/>
        <c:lblOffset val="100"/>
        <c:noMultiLvlLbl val="0"/>
      </c:catAx>
      <c:valAx>
        <c:axId val="1548653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8654064"/>
        <c:crosses val="autoZero"/>
        <c:crossBetween val="between"/>
        <c:majorUnit val="1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0253718285214"/>
          <c:y val="5.6632040994351991E-2"/>
          <c:w val="0.76982648002333043"/>
          <c:h val="0.477621515815590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63'!$G$5:$G$8</c:f>
                <c:numCache>
                  <c:formatCode>General</c:formatCode>
                  <c:ptCount val="4"/>
                  <c:pt idx="0">
                    <c:v>2.0496371026112268</c:v>
                  </c:pt>
                  <c:pt idx="1">
                    <c:v>2.2359677483031515</c:v>
                  </c:pt>
                  <c:pt idx="2">
                    <c:v>4.0992742052224385</c:v>
                  </c:pt>
                  <c:pt idx="3">
                    <c:v>4.2856048509143809</c:v>
                  </c:pt>
                </c:numCache>
              </c:numRef>
            </c:plus>
            <c:minus>
              <c:numRef>
                <c:f>'63'!$G$5:$G$8</c:f>
                <c:numCache>
                  <c:formatCode>General</c:formatCode>
                  <c:ptCount val="4"/>
                  <c:pt idx="0">
                    <c:v>2.0496371026112268</c:v>
                  </c:pt>
                  <c:pt idx="1">
                    <c:v>2.2359677483031515</c:v>
                  </c:pt>
                  <c:pt idx="2">
                    <c:v>4.0992742052224385</c:v>
                  </c:pt>
                  <c:pt idx="3">
                    <c:v>4.28560485091438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63'!$A$5:$A$8</c:f>
              <c:strCache>
                <c:ptCount val="4"/>
                <c:pt idx="0">
                  <c:v>No HIV/ no drug</c:v>
                </c:pt>
                <c:pt idx="1">
                  <c:v>HIV/no drug</c:v>
                </c:pt>
                <c:pt idx="2">
                  <c:v>HIV+10ug fentanyl</c:v>
                </c:pt>
                <c:pt idx="3">
                  <c:v>HIV+10ug fentanyl+10ug naltrexone</c:v>
                </c:pt>
              </c:strCache>
            </c:strRef>
          </c:cat>
          <c:val>
            <c:numRef>
              <c:f>'63'!$F$5:$F$8</c:f>
              <c:numCache>
                <c:formatCode>General</c:formatCode>
                <c:ptCount val="4"/>
                <c:pt idx="0">
                  <c:v>8.5333184930312154</c:v>
                </c:pt>
                <c:pt idx="1">
                  <c:v>48.191773089632264</c:v>
                </c:pt>
                <c:pt idx="2">
                  <c:v>75.860462343074857</c:v>
                </c:pt>
                <c:pt idx="3">
                  <c:v>45.424904164288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C0-4681-9627-87B5C6167F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243983"/>
        <c:axId val="1884350575"/>
      </c:barChart>
      <c:catAx>
        <c:axId val="1412439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15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84350575"/>
        <c:crosses val="autoZero"/>
        <c:auto val="1"/>
        <c:lblAlgn val="ctr"/>
        <c:lblOffset val="100"/>
        <c:noMultiLvlLbl val="0"/>
      </c:catAx>
      <c:valAx>
        <c:axId val="18843505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124398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851</cdr:x>
      <cdr:y>0</cdr:y>
    </cdr:from>
    <cdr:to>
      <cdr:x>0.16667</cdr:x>
      <cdr:y>0.64194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A2B07ED-FEB2-0D3D-168F-4DB68F46D945}"/>
            </a:ext>
          </a:extLst>
        </cdr:cNvPr>
        <cdr:cNvSpPr txBox="1"/>
      </cdr:nvSpPr>
      <cdr:spPr>
        <a:xfrm xmlns:a="http://schemas.openxmlformats.org/drawingml/2006/main" rot="16200000">
          <a:off x="-398466" y="851615"/>
          <a:ext cx="2212109" cy="50887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DNA proviral load</a:t>
          </a:r>
        </a:p>
        <a:p xmlns:a="http://schemas.openxmlformats.org/drawingml/2006/main">
          <a:pPr algn="ctr"/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(log copies / 1 × 10</a:t>
          </a:r>
          <a:r>
            <a:rPr 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cells</a:t>
          </a:r>
          <a:r>
            <a:rPr lang="en-US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934</cdr:x>
      <cdr:y>0.04286</cdr:y>
    </cdr:from>
    <cdr:to>
      <cdr:x>0.14548</cdr:x>
      <cdr:y>0.4901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E865C1D8-282D-4780-8A65-FCD40EC6FDA9}"/>
            </a:ext>
          </a:extLst>
        </cdr:cNvPr>
        <cdr:cNvSpPr txBox="1"/>
      </cdr:nvSpPr>
      <cdr:spPr>
        <a:xfrm xmlns:a="http://schemas.openxmlformats.org/drawingml/2006/main" rot="16200000">
          <a:off x="-127038" y="802042"/>
          <a:ext cx="1590675" cy="2913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400" b="0" i="0" baseline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HIV p24 (pg/mL)</a:t>
          </a:r>
          <a:endParaRPr lang="en-US" sz="140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47F0D1-A573-4C19-8851-753B49F734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8B2C91-F8F3-4819-922D-D6CF85D020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F58CF5-7103-48A2-BFD7-26C36D74B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D43FC6-89AF-4567-B251-3F5BE3218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EE8DD7-688D-4672-9002-2F0EF3915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618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29BA1-6722-4AA0-B8D7-9BBBEBBF82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2B9A13-04E9-48A8-B665-5A75B1D957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2F88E5-9988-4E14-A9F8-B8E49EF2F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6C336A-0F63-47CF-84FF-7090DF06F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953001-E091-49C9-AEA1-490228F89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679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BFDEEC-6B42-4FB9-ADF8-DCCB0C7862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0D0985-9BA7-4061-A0C8-60929B0359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317FF1-8161-4A37-AEF6-B433A82A7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82BE0A-DABB-4B37-8A3F-3DB132986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E510A-2F1D-4F7F-B456-D67520064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463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58D2DB-1BE3-4192-8725-63078B6765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55599D-65C5-4C19-BF1E-4B283D8F52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BEDDB7-F339-4573-9EAD-CB26471FB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36FC8C-6AA3-4CDF-B8BF-7AF9FBC71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0EC18F-F25D-45CF-A5D7-0564A820B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019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B60B3B-EC53-4C89-AB05-70E883BEE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292745-C1B1-444B-996B-1F1147A317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6D90A8-A7D2-4EE6-9488-51FE3DC74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356CD8-9552-42EF-BFED-DE5FB9488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4BFEF4-CCF0-4D5E-A7FB-8D18E3662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10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AB55D8-439D-4288-8A1D-643F8A237A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021EFF-E46B-4648-9EE3-B3E7400428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0F429D-7F8B-4ED5-AA4F-74D1CB2C3C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E26E23-296F-4B05-9583-E57850F18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D46E42-8EB0-47E4-BD33-A5413ED3B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31E4CF-93F3-4896-BA4D-DA8938069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67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3A0217-CE7D-4B6F-9B32-9A2A8872F2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47F2D3-B695-4E64-BF3E-9E9EC0D4CF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2BD72A-E766-4FCF-8353-9CA2C432D2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81A734-D72C-410B-990F-9E330A3A25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1FB218-F818-4E99-BD36-CC6D6DF564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ED580F-E83C-42E8-8303-31F3A3404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D93506-3F57-42C8-AD15-2E8C61C6D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3DD2793-9DE4-47C7-89EB-0EA215966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67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ABE68-8510-4629-915E-B543FA75FE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D0474B-8DF5-40EB-8A69-724F537AA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85EFDC-2526-45D7-AE87-60A4BFA44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2902C5-9B04-42F3-92F0-161F06ED2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448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637812A-587B-4B9F-BD5A-7C4F0809F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00A5F3-1548-4726-94AF-50ECF0E79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9377B1-22AB-474C-84FE-0D0DB5530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237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3E2E22-3EBD-4969-9F80-28FE3FE235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241F49-2433-44CD-9CDA-026163B3CA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753851-8E07-484E-BE97-0A468AD129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8883B3-BA8B-4B0A-A27F-855D2C4F2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28AD9D-3CDF-40B3-A4E9-339A95F53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22924A-1165-4F7B-ABF1-C7FB14E63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93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282D97-9707-4F52-ADC9-D102367443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8C1005-8C51-45B6-8683-207C704FB7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C6E7AA-FCC8-4844-8181-D6CC3E895F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148627-5301-4EB5-8580-E9995F282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6E08C8-42B5-4482-B4B1-C2128601C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5A926A-9968-404D-9B95-1771A2CDD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485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72C1B9-8A4C-44E8-8E08-46C60CCCC1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DBC421-6DAA-44CC-8964-E6CE237040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F499C3-2A4E-43A2-A9A6-100359C18B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22740-C6C6-4387-B2FB-54972AF80D88}" type="datetimeFigureOut">
              <a:rPr lang="en-US" smtClean="0"/>
              <a:t>7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C03235-CBD3-46D5-A391-E37888A0ED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FFE973-6C20-45E8-B1EB-0ED7CF779C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58AAC2-24AD-4C48-85B6-B7C6BFF8A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342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47EB84A-6586-4CEA-AA4E-0C27E3B711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8817769"/>
              </p:ext>
            </p:extLst>
          </p:nvPr>
        </p:nvGraphicFramePr>
        <p:xfrm>
          <a:off x="34504" y="1396960"/>
          <a:ext cx="6356985" cy="35975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F76914D-1988-694F-4512-5639F1C4AE20}"/>
              </a:ext>
            </a:extLst>
          </p:cNvPr>
          <p:cNvSpPr txBox="1"/>
          <p:nvPr/>
        </p:nvSpPr>
        <p:spPr>
          <a:xfrm>
            <a:off x="10802680" y="122565"/>
            <a:ext cx="13025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ontrol ID : 66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2FEFFB8-244A-413B-B882-96EDBCE23B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321769"/>
              </p:ext>
            </p:extLst>
          </p:nvPr>
        </p:nvGraphicFramePr>
        <p:xfrm>
          <a:off x="5858919" y="1529359"/>
          <a:ext cx="5595056" cy="3555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8B1F4489-0969-40FA-8B35-772FAAEC6FEE}"/>
              </a:ext>
            </a:extLst>
          </p:cNvPr>
          <p:cNvSpPr txBox="1"/>
          <p:nvPr/>
        </p:nvSpPr>
        <p:spPr>
          <a:xfrm>
            <a:off x="0" y="5842337"/>
            <a:ext cx="12192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PBMC derived </a:t>
            </a:r>
            <a:r>
              <a:rPr lang="en-US" sz="1200" dirty="0">
                <a:latin typeface="Times New Roman" panose="02020603050405020304" pitchFamily="18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 cells were seeded at ~1 × 10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 per well. 10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 of naltrexone was added into the respective well and the cells are incubated for 24 hrs. After incubation cells were infected with HIV</a:t>
            </a:r>
            <a:r>
              <a:rPr lang="en-US" sz="105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L4-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 at MOI of 1 for 2 hours and rinsed with RPMI + 10% FBS + 1% antibiotics (Pen/Strep) + 1% glutamine for three times to remove any unbound virus and replaced with fresh media. Fentanyl at concentration of 10ug/mL was added to the respective well and incubated. After incubation with drug and virus for 72 hours, HIV proviral DNA was quantified in cells by real-time PCR based on SYBR Green I detection and HIV p24 antigen expression was estimated from the cell culture supernatant. Error bar represents the standard deviations between the replicates.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3186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ravasal Krishnan, Janani (jananimk)</dc:creator>
  <cp:lastModifiedBy>Madhuravasal Krishnan, Janani (jananimk)</cp:lastModifiedBy>
  <cp:revision>1</cp:revision>
  <dcterms:created xsi:type="dcterms:W3CDTF">2024-06-12T20:06:25Z</dcterms:created>
  <dcterms:modified xsi:type="dcterms:W3CDTF">2024-07-11T18:37:59Z</dcterms:modified>
</cp:coreProperties>
</file>